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4" r:id="rId2"/>
  </p:sldIdLst>
  <p:sldSz cx="12192000" cy="6858000"/>
  <p:notesSz cx="6858000" cy="994727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972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0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4D2805E-962A-4C73-BA57-A4D0A074EC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234EED5A-A864-4CFE-B21A-240F8F517A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E383890-DC17-4DF0-BD48-047A40C5A2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69CA383-5E82-48F6-B458-967C03826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6FFDD1A-28DD-4AC8-A528-9148740E8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208009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36ACA31-5BD5-4EFA-827D-2E0DA9F334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D1F48750-F805-4DE2-BEC7-8AA9AEC389B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762E1306-90B1-4B23-8C06-2A2921A05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5C6DCC8-53F1-4C2A-8FEC-DFCAF27B5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BF398E5-D328-4035-8BD5-92E74C3F4A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4437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256DDCBC-A8A0-4F74-95F0-F6640566EF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870D467-DE20-42AE-8A56-FE39F5E46A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8FC0D74-4306-4283-8582-29E0BD4F82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8D9FC61-903F-4E32-BB42-8E05261B46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14879E9-A271-4A56-83A2-351B7DD95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26129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D455201-A692-4ADC-A5E1-64C0EBA305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3B8878A-5B71-440D-BBF5-A6C2BBB5D3B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4CB062A-6EBE-4FEB-BA99-64DCAA290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CB90496-DFC0-4A0B-AA3C-F694A7A95C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8B867EBC-FA82-477E-90E7-FF2486F68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3789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085C4D5-5979-4A99-84AC-95D2FC4742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193C1FE-E21C-4A55-BCAE-5A61FA9134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066FA94-BD02-4943-ADF1-B1A2A2FB2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500D149C-127A-4943-892E-DFC0AE1EE7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BACEDACA-9FCC-43BF-8544-46B65450E0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5937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823AB2C-ECDA-4E8D-909E-EE1BB1C212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9FA64AF-914E-4178-88CF-9EA18251719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2DF644E-5D91-48A7-B2A9-FBECAE9082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969637A-819A-44EE-BA6E-1B6D804CED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79FA97E-CB75-417A-A586-84897410C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6FAE076-A343-4077-B9AD-A475250DD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14361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2810ADB-26FC-43E6-B6BC-CB64CE9B42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18C2502-DE14-40DC-8161-6E3E935015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ED8E12A5-F51E-4654-8221-45CCCF4B9A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2051302-DF28-473C-BD67-A732342C3C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F4921145-80F3-4BD3-B9AF-37A292ACA9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EC68B6D6-E372-4A4D-A9BC-EE19E7040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CDA9A4DE-E500-4359-AC6F-7F2B19993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3EF6BE77-FCE7-4E78-B9DD-23F032A01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024966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5EC9E5E-A889-4569-9702-B75DE2DBC6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76347324-427A-4F7C-88E4-B21301E897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1243126-523F-4FA5-97DB-FC4987E838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B06A895-ABC6-432E-9782-943D65C8B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058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532DA76-D74F-423A-9193-85D13AFB9A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B110BDBC-A645-41DF-97C5-4C2805ABF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6D814874-9463-418C-A8FC-259FA648C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1423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CFEC235-5D80-4FE8-B11F-016F77C4F9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9043C99-1683-48F9-B04B-498B08B412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B98314AD-94F8-41AB-8D48-62585C13A8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06A9F9D-021F-40BC-A8CF-5AEC003F22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E0F0A2F-3235-405A-9399-8D294AF1EF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76267C7E-BC2A-4A7F-8219-789441D1B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82347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3F9C4AB-276B-4DD3-A8B6-BBF17915F1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7A9C1F0-AF91-4917-AA83-049E2E5654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EBB385D4-07A0-4341-8DF2-52C816C87E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0DA43DC9-4F26-42E7-BF0B-372C3350D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44913C3D-9A16-4AE9-AC43-83BAF99BC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3D16D7B-EC08-4A46-8C33-C64905CFC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62521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EC5ABC85-9D41-4241-9A6B-94B8566FD6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6CB6D9C-0849-4942-9AA5-FE9E51CB1C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FCE95A3-2616-4DC6-8F02-28740F25ABA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15C65D-06AC-443A-BFEF-F7D70FEF08D1}" type="datetimeFigureOut">
              <a:rPr lang="ko-KR" altLang="en-US" smtClean="0"/>
              <a:t>2023-04-0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7CE39A8-C45C-4E99-8269-9EC03136B0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1D91B25-662D-4A54-9F50-5815BD19D1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E828B6-50E5-4829-96E3-46475C41B93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7048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1256084" y="102702"/>
            <a:ext cx="9708249" cy="6619063"/>
            <a:chOff x="1289951" y="-517520"/>
            <a:chExt cx="9708249" cy="6619063"/>
          </a:xfrm>
        </p:grpSpPr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6F94C53-96E9-4D7C-9A0C-649CD96954BA}"/>
                </a:ext>
              </a:extLst>
            </p:cNvPr>
            <p:cNvSpPr txBox="1"/>
            <p:nvPr/>
          </p:nvSpPr>
          <p:spPr>
            <a:xfrm>
              <a:off x="3317583" y="619264"/>
              <a:ext cx="5362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.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6F94C53-96E9-4D7C-9A0C-649CD96954BA}"/>
                </a:ext>
              </a:extLst>
            </p:cNvPr>
            <p:cNvSpPr txBox="1"/>
            <p:nvPr/>
          </p:nvSpPr>
          <p:spPr>
            <a:xfrm>
              <a:off x="6347712" y="619264"/>
              <a:ext cx="54483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.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36F94C53-96E9-4D7C-9A0C-649CD96954BA}"/>
                </a:ext>
              </a:extLst>
            </p:cNvPr>
            <p:cNvSpPr txBox="1"/>
            <p:nvPr/>
          </p:nvSpPr>
          <p:spPr>
            <a:xfrm>
              <a:off x="3317583" y="3361434"/>
              <a:ext cx="53620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.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6F94C53-96E9-4D7C-9A0C-649CD96954BA}"/>
                </a:ext>
              </a:extLst>
            </p:cNvPr>
            <p:cNvSpPr txBox="1"/>
            <p:nvPr/>
          </p:nvSpPr>
          <p:spPr>
            <a:xfrm>
              <a:off x="6336307" y="3361434"/>
              <a:ext cx="5562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.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모서리가 둥근 직사각형 42"/>
            <p:cNvSpPr/>
            <p:nvPr/>
          </p:nvSpPr>
          <p:spPr>
            <a:xfrm>
              <a:off x="3124199" y="182881"/>
              <a:ext cx="6169429" cy="5918662"/>
            </a:xfrm>
            <a:prstGeom prst="roundRect">
              <a:avLst>
                <a:gd name="adj" fmla="val 2862"/>
              </a:avLst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직사각형 43"/>
            <p:cNvSpPr/>
            <p:nvPr/>
          </p:nvSpPr>
          <p:spPr>
            <a:xfrm>
              <a:off x="1289951" y="-517520"/>
              <a:ext cx="9708249" cy="63594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>
                <a:lnSpc>
                  <a:spcPct val="115000"/>
                </a:lnSpc>
                <a:spcAft>
                  <a:spcPts val="1000"/>
                </a:spcAft>
              </a:pPr>
              <a:r>
                <a:rPr lang="en-US" altLang="ko-KR" sz="1600" b="1" dirty="0">
                  <a:latin typeface="Times New Roman" panose="02020603050405020304" pitchFamily="18" charset="0"/>
                </a:rPr>
                <a:t>Additional file1: Figure S1. </a:t>
              </a:r>
              <a:r>
                <a:rPr lang="en-US" altLang="ko-KR" sz="1600" dirty="0">
                  <a:latin typeface="Times New Roman" panose="02020603050405020304" pitchFamily="18" charset="0"/>
                </a:rPr>
                <a:t>Effects of HFD and VWR exercise on mRNA expression of PGC-1</a:t>
              </a:r>
              <a:r>
                <a:rPr lang="el-GR" altLang="ko-KR" sz="1600" dirty="0">
                  <a:latin typeface="Times New Roman" panose="02020603050405020304" pitchFamily="18" charset="0"/>
                </a:rPr>
                <a:t>α</a:t>
              </a:r>
              <a:r>
                <a:rPr lang="en-US" altLang="ko-KR" sz="1600" dirty="0">
                  <a:latin typeface="Times New Roman" panose="02020603050405020304" pitchFamily="18" charset="0"/>
                </a:rPr>
                <a:t> (A), FNDC5 (B) in white region of gastrocnemius muscle and PGC-1</a:t>
              </a:r>
              <a:r>
                <a:rPr lang="el-GR" altLang="ko-KR" sz="1600" dirty="0">
                  <a:latin typeface="Times New Roman" panose="02020603050405020304" pitchFamily="18" charset="0"/>
                </a:rPr>
                <a:t> α</a:t>
              </a:r>
              <a:r>
                <a:rPr lang="en-US" altLang="ko-KR" sz="1600" dirty="0">
                  <a:latin typeface="Times New Roman" panose="02020603050405020304" pitchFamily="18" charset="0"/>
                </a:rPr>
                <a:t> (C), FNDC5 (D) in red region of gastrocnemius muscle.  </a:t>
              </a:r>
              <a:endParaRPr lang="ko-KR" altLang="ko-KR" sz="1600" dirty="0">
                <a:effectLst/>
                <a:latin typeface="Times New Roman" panose="02020603050405020304" pitchFamily="18" charset="0"/>
                <a:ea typeface="바탕" panose="02030600000101010101" pitchFamily="18" charset="-127"/>
              </a:endParaRPr>
            </a:p>
          </p:txBody>
        </p:sp>
        <p:pic>
          <p:nvPicPr>
            <p:cNvPr id="6" name="그림 5"/>
            <p:cNvPicPr preferRelativeResize="0">
              <a:picLocks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17607" y="771141"/>
              <a:ext cx="2880000" cy="2520000"/>
            </a:xfrm>
            <a:prstGeom prst="rect">
              <a:avLst/>
            </a:prstGeom>
          </p:spPr>
        </p:pic>
        <p:pic>
          <p:nvPicPr>
            <p:cNvPr id="9" name="그림 8"/>
            <p:cNvPicPr preferRelativeResize="0">
              <a:picLocks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3916" y="771141"/>
              <a:ext cx="2880000" cy="2520000"/>
            </a:xfrm>
            <a:prstGeom prst="rect">
              <a:avLst/>
            </a:prstGeom>
          </p:spPr>
        </p:pic>
        <p:pic>
          <p:nvPicPr>
            <p:cNvPr id="13" name="그림 12"/>
            <p:cNvPicPr preferRelativeResize="0">
              <a:picLocks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17607" y="3514339"/>
              <a:ext cx="2880000" cy="2520000"/>
            </a:xfrm>
            <a:prstGeom prst="rect">
              <a:avLst/>
            </a:prstGeom>
          </p:spPr>
        </p:pic>
        <p:pic>
          <p:nvPicPr>
            <p:cNvPr id="14" name="그림 13"/>
            <p:cNvPicPr preferRelativeResize="0">
              <a:picLocks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73916" y="3514339"/>
              <a:ext cx="2880000" cy="252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91856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92</TotalTime>
  <Words>56</Words>
  <Application>Microsoft Office PowerPoint</Application>
  <PresentationFormat>와이드스크린</PresentationFormat>
  <Paragraphs>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바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조 채은</dc:creator>
  <cp:lastModifiedBy>Sewon Lee</cp:lastModifiedBy>
  <cp:revision>159</cp:revision>
  <cp:lastPrinted>2022-02-17T01:29:38Z</cp:lastPrinted>
  <dcterms:created xsi:type="dcterms:W3CDTF">2020-12-08T06:36:36Z</dcterms:created>
  <dcterms:modified xsi:type="dcterms:W3CDTF">2023-04-09T02:48:06Z</dcterms:modified>
</cp:coreProperties>
</file>